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518945" y="1871266"/>
            <a:ext cx="4988063" cy="386226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68161" y="5733534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OS in patients with and without vascular invasion of their tumor.  Log-rank test demonstrated no significant association between OS and vascular invas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8851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3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11:20Z</dcterms:modified>
</cp:coreProperties>
</file>